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2" r:id="rId2"/>
    <p:sldId id="321" r:id="rId3"/>
    <p:sldId id="317" r:id="rId4"/>
    <p:sldId id="316" r:id="rId5"/>
    <p:sldId id="32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224" autoAdjust="0"/>
  </p:normalViewPr>
  <p:slideViewPr>
    <p:cSldViewPr snapToGrid="0">
      <p:cViewPr varScale="1">
        <p:scale>
          <a:sx n="89" d="100"/>
          <a:sy n="89" d="100"/>
        </p:scale>
        <p:origin x="84" y="1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BEFFCA-04A7-41D7-879D-7DA9B6D262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AB89E10-37F6-4B38-9D11-8492F37379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3242EC-8D3C-4C44-A629-A648DA443D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C9A41-DFCC-425D-9205-7F82EE8D603C}" type="datetimeFigureOut">
              <a:rPr lang="en-US" smtClean="0"/>
              <a:t>9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562411-9015-43B1-989A-9299A72E8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C4B70F-883A-4DA1-91E3-BB7CC1D96B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8687-960C-4ADA-A7A9-04AD3C84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16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39C936-A611-409D-A2B6-9258223717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47FBC5-DBCF-40F7-82B7-589CE7D624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E726F0-E63E-4564-867E-78357E335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C9A41-DFCC-425D-9205-7F82EE8D603C}" type="datetimeFigureOut">
              <a:rPr lang="en-US" smtClean="0"/>
              <a:t>9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C1BFF-23AF-4E96-B0C3-004CACDC5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2BD548-4BC6-45F6-8E4E-F6880D7A3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8687-960C-4ADA-A7A9-04AD3C84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743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C4A4FBA-D456-4619-A24D-33381B501D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FC7777-F022-47A6-9A2B-FD51F3DB60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A946B4-3405-4412-82A2-0241C5201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C9A41-DFCC-425D-9205-7F82EE8D603C}" type="datetimeFigureOut">
              <a:rPr lang="en-US" smtClean="0"/>
              <a:t>9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F8CC7C-46AC-47C3-ADCD-CB3338471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F4A01C-AE78-404B-BB18-495091B6BB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8687-960C-4ADA-A7A9-04AD3C84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045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D19D42-DDEB-424D-A0E5-864A8C688F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239C50-83C0-407B-8D12-7FB127ED4C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1DDFDF-D48D-44CB-9720-4244395CD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C9A41-DFCC-425D-9205-7F82EE8D603C}" type="datetimeFigureOut">
              <a:rPr lang="en-US" smtClean="0"/>
              <a:t>9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D9170D-A0F6-45EB-B227-616E1E568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A30790-9CB5-4476-AA76-BF9E7F3F1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8687-960C-4ADA-A7A9-04AD3C84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60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72F595-21CD-41E1-97A7-26131E695C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D2F940-D053-499B-AD6E-A0A5FE0F26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842EB5-DAE5-4FA6-89FF-1CE07D4E1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C9A41-DFCC-425D-9205-7F82EE8D603C}" type="datetimeFigureOut">
              <a:rPr lang="en-US" smtClean="0"/>
              <a:t>9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8284A5-CB37-4653-87AA-2162A279F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D4E50B-9954-4AE3-B6E7-9E32491A4D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8687-960C-4ADA-A7A9-04AD3C84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952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D16B69-AEB3-4A51-BD79-90B2B29510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8D2B27-A707-4992-90F6-0BAEDABB4B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C0B932-17E5-49D0-9E77-C8C92E85BB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A75995-1934-44C6-8F06-3C43F791A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C9A41-DFCC-425D-9205-7F82EE8D603C}" type="datetimeFigureOut">
              <a:rPr lang="en-US" smtClean="0"/>
              <a:t>9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B457C8-031A-4224-937C-F8420A43F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67FC2E-953E-49A0-BBB0-AA3D0D40A5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8687-960C-4ADA-A7A9-04AD3C84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245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19054A-D9B4-4DAF-BC88-8179E673C8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AFD08C-9C38-4C2F-9A4C-CE4C6BED35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587F74-6EF2-467B-8B38-45A3460F98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FACEBFD-A939-498F-803B-19B928427A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EA022B-E6CD-4829-9FA3-5F41A3B0E6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5EFA9C6-285E-4D15-8C39-1FA01857B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C9A41-DFCC-425D-9205-7F82EE8D603C}" type="datetimeFigureOut">
              <a:rPr lang="en-US" smtClean="0"/>
              <a:t>9/2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9FC41FD-AFCB-4A3F-BBCF-954E15B75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E89BBD4-3611-4E97-B9DE-592138428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8687-960C-4ADA-A7A9-04AD3C84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6566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F4E6B4-4F37-4A5E-9FE4-741D7F6AC5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782E2BB-7A77-4518-8515-4D4963FAB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C9A41-DFCC-425D-9205-7F82EE8D603C}" type="datetimeFigureOut">
              <a:rPr lang="en-US" smtClean="0"/>
              <a:t>9/2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89572A-8F23-474A-8FE6-16A28CA47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063068-FD86-4645-9AD9-8ADD1FB93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8687-960C-4ADA-A7A9-04AD3C84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352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6C36CD3-C8B5-487C-9270-0D9F75D12E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C9A41-DFCC-425D-9205-7F82EE8D603C}" type="datetimeFigureOut">
              <a:rPr lang="en-US" smtClean="0"/>
              <a:t>9/2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537B4B-479B-4FBD-9B83-EDDE58782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EEA2ED-1694-4230-9E3E-4723D61130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8687-960C-4ADA-A7A9-04AD3C84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107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CCFEC9-F1DE-4496-A4D1-FD985C7773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AE9DEA-1405-4A2D-8E5C-866FE0EF8A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D7A659-6334-45CD-9B7D-F09FBE4E12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F95D4E-02F1-4371-96B3-C01CFB8BC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C9A41-DFCC-425D-9205-7F82EE8D603C}" type="datetimeFigureOut">
              <a:rPr lang="en-US" smtClean="0"/>
              <a:t>9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3DD0E9-2674-4195-8E5A-740385AF3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9353FF-C395-45B7-9DDD-D0C42F849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8687-960C-4ADA-A7A9-04AD3C84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159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D4062-0737-4021-A7DE-D284E8E109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CF6E01A-C322-4F43-AF39-93A8EC883F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0602CD-34EC-47D7-9CF2-56017D3CC2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E06605-0D4F-43E0-BA03-1FD392E62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C9A41-DFCC-425D-9205-7F82EE8D603C}" type="datetimeFigureOut">
              <a:rPr lang="en-US" smtClean="0"/>
              <a:t>9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C4B2DB-D617-4A85-8F47-90FB46DA5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2C8C8A-2532-4F1D-8106-4F2FE13AE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28687-960C-4ADA-A7A9-04AD3C84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475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11124B4-E2B2-4EC6-94A2-1EF9579EBD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4B088D-946F-48F2-9483-66379FB862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B333D6-7C2F-4DDB-998E-2D8A0ACC49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0C9A41-DFCC-425D-9205-7F82EE8D603C}" type="datetimeFigureOut">
              <a:rPr lang="en-US" smtClean="0"/>
              <a:t>9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6810FC-BAC0-49CC-9379-00AB2763DF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CF29FD-E927-4EBE-9225-D64ACBE563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F28687-960C-4ADA-A7A9-04AD3C84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313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diagram&#10;&#10;Description automatically generated">
            <a:extLst>
              <a:ext uri="{FF2B5EF4-FFF2-40B4-BE49-F238E27FC236}">
                <a16:creationId xmlns:a16="http://schemas.microsoft.com/office/drawing/2014/main" id="{9C653E28-9F28-460F-8EAE-72B23E25F95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25" t="6406" r="41509"/>
          <a:stretch/>
        </p:blipFill>
        <p:spPr>
          <a:xfrm>
            <a:off x="8208562" y="780458"/>
            <a:ext cx="3862629" cy="53333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7CC4D8A3-EDDF-4DBB-9ECD-11A6A770C59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46" t="6406" r="60600"/>
          <a:stretch/>
        </p:blipFill>
        <p:spPr>
          <a:xfrm>
            <a:off x="4053480" y="780458"/>
            <a:ext cx="4091710" cy="53333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 descr="A picture containing diagram&#10;&#10;Description automatically generated">
            <a:extLst>
              <a:ext uri="{FF2B5EF4-FFF2-40B4-BE49-F238E27FC236}">
                <a16:creationId xmlns:a16="http://schemas.microsoft.com/office/drawing/2014/main" id="{41F63C1C-B510-40D3-833D-8538D814A3E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61" r="80871"/>
          <a:stretch/>
        </p:blipFill>
        <p:spPr>
          <a:xfrm>
            <a:off x="0" y="780456"/>
            <a:ext cx="3990108" cy="53333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393181A-7A73-4683-93C8-2814AE99712B}"/>
              </a:ext>
            </a:extLst>
          </p:cNvPr>
          <p:cNvSpPr txBox="1"/>
          <p:nvPr/>
        </p:nvSpPr>
        <p:spPr>
          <a:xfrm>
            <a:off x="506994" y="280657"/>
            <a:ext cx="103324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: Kruskal-Wallis Abundance of Virulence Factors between Cirrhosis Subgroups with FDR correctio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AEB3CCD-6A85-402A-A238-3841B71E8C5D}"/>
              </a:ext>
            </a:extLst>
          </p:cNvPr>
          <p:cNvSpPr txBox="1"/>
          <p:nvPr/>
        </p:nvSpPr>
        <p:spPr>
          <a:xfrm>
            <a:off x="923454" y="6142059"/>
            <a:ext cx="1731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: Compensate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2EF2A8D-22FD-4F9D-BE30-1D26116CFF12}"/>
              </a:ext>
            </a:extLst>
          </p:cNvPr>
          <p:cNvSpPr txBox="1"/>
          <p:nvPr/>
        </p:nvSpPr>
        <p:spPr>
          <a:xfrm>
            <a:off x="5349090" y="6113845"/>
            <a:ext cx="1562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: Ascites Only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E12020C-24C6-4E95-838F-C4A97461624B}"/>
              </a:ext>
            </a:extLst>
          </p:cNvPr>
          <p:cNvSpPr txBox="1"/>
          <p:nvPr/>
        </p:nvSpPr>
        <p:spPr>
          <a:xfrm>
            <a:off x="9358700" y="6092948"/>
            <a:ext cx="1164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: HE Only</a:t>
            </a:r>
          </a:p>
        </p:txBody>
      </p:sp>
    </p:spTree>
    <p:extLst>
      <p:ext uri="{BB962C8B-B14F-4D97-AF65-F5344CB8AC3E}">
        <p14:creationId xmlns:p14="http://schemas.microsoft.com/office/powerpoint/2010/main" val="6665493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diagram&#10;&#10;Description automatically generated">
            <a:extLst>
              <a:ext uri="{FF2B5EF4-FFF2-40B4-BE49-F238E27FC236}">
                <a16:creationId xmlns:a16="http://schemas.microsoft.com/office/drawing/2014/main" id="{4AC597A7-6C7A-4313-A4A8-A041BE28AEC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621" t="6060" b="3899"/>
          <a:stretch/>
        </p:blipFill>
        <p:spPr>
          <a:xfrm>
            <a:off x="6648865" y="1095468"/>
            <a:ext cx="4896182" cy="54081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 descr="A picture containing diagram&#10;&#10;Description automatically generated">
            <a:extLst>
              <a:ext uri="{FF2B5EF4-FFF2-40B4-BE49-F238E27FC236}">
                <a16:creationId xmlns:a16="http://schemas.microsoft.com/office/drawing/2014/main" id="{66F53253-6D4E-437C-B2B4-8A6AF069A16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62" t="6142" r="20275" b="2397"/>
          <a:stretch/>
        </p:blipFill>
        <p:spPr>
          <a:xfrm>
            <a:off x="1549057" y="1095469"/>
            <a:ext cx="5005652" cy="54081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352C071-CEF2-48B6-BB0C-A7BFD7554510}"/>
              </a:ext>
            </a:extLst>
          </p:cNvPr>
          <p:cNvSpPr txBox="1"/>
          <p:nvPr/>
        </p:nvSpPr>
        <p:spPr>
          <a:xfrm>
            <a:off x="506994" y="280657"/>
            <a:ext cx="11187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 continued: Kruskal-Wallis Abundance of Virulence Factors between Cirrhosis Subgroups with FDR correctio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949B828-0F68-4FA3-834E-FA0BE09D8C52}"/>
              </a:ext>
            </a:extLst>
          </p:cNvPr>
          <p:cNvSpPr txBox="1"/>
          <p:nvPr/>
        </p:nvSpPr>
        <p:spPr>
          <a:xfrm>
            <a:off x="2931814" y="6488668"/>
            <a:ext cx="23109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: Both Ascites and H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E0C8E52-4597-438D-A98E-D6A1219DCCA7}"/>
              </a:ext>
            </a:extLst>
          </p:cNvPr>
          <p:cNvSpPr txBox="1"/>
          <p:nvPr/>
        </p:nvSpPr>
        <p:spPr>
          <a:xfrm>
            <a:off x="8407651" y="6488668"/>
            <a:ext cx="1995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: Infected patients</a:t>
            </a:r>
          </a:p>
        </p:txBody>
      </p:sp>
    </p:spTree>
    <p:extLst>
      <p:ext uri="{BB962C8B-B14F-4D97-AF65-F5344CB8AC3E}">
        <p14:creationId xmlns:p14="http://schemas.microsoft.com/office/powerpoint/2010/main" val="38792157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286E40BD-5903-4E0E-87D1-700B3B9B616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79" r="51908" b="2424"/>
          <a:stretch/>
        </p:blipFill>
        <p:spPr>
          <a:xfrm>
            <a:off x="2490867" y="113794"/>
            <a:ext cx="4335445" cy="63141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2C739723-9524-42E3-9BFA-9B95717B4F2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979" t="5679" r="1503" b="2424"/>
          <a:stretch/>
        </p:blipFill>
        <p:spPr>
          <a:xfrm>
            <a:off x="6989324" y="113794"/>
            <a:ext cx="4463310" cy="63132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B4CC1DBB-EC63-40D5-A8A6-588A26133DEF}"/>
              </a:ext>
            </a:extLst>
          </p:cNvPr>
          <p:cNvSpPr/>
          <p:nvPr/>
        </p:nvSpPr>
        <p:spPr>
          <a:xfrm>
            <a:off x="0" y="3270411"/>
            <a:ext cx="1982709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A: MaAsLin2 coefficients of variables linked with ↓ hospitalizations</a:t>
            </a:r>
          </a:p>
          <a:p>
            <a:r>
              <a:rPr lang="en-US" dirty="0"/>
              <a:t>B: MaAsLin2 coefficients of variables linked with ↑ hospitalization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C64F096-97F1-4E64-A6CD-DC3E218BEDB8}"/>
              </a:ext>
            </a:extLst>
          </p:cNvPr>
          <p:cNvSpPr txBox="1"/>
          <p:nvPr/>
        </p:nvSpPr>
        <p:spPr>
          <a:xfrm>
            <a:off x="2490867" y="605769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8B94CCD-7109-4A06-8625-699440B31406}"/>
              </a:ext>
            </a:extLst>
          </p:cNvPr>
          <p:cNvSpPr txBox="1"/>
          <p:nvPr/>
        </p:nvSpPr>
        <p:spPr>
          <a:xfrm>
            <a:off x="7046981" y="605769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2135DED-1A89-47FF-9E4D-029DD90D741B}"/>
              </a:ext>
            </a:extLst>
          </p:cNvPr>
          <p:cNvSpPr txBox="1"/>
          <p:nvPr/>
        </p:nvSpPr>
        <p:spPr>
          <a:xfrm>
            <a:off x="153908" y="540601"/>
            <a:ext cx="2285497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2</a:t>
            </a:r>
          </a:p>
          <a:p>
            <a:r>
              <a:rPr lang="en-US" dirty="0"/>
              <a:t>Multi-variable analysis</a:t>
            </a:r>
          </a:p>
          <a:p>
            <a:r>
              <a:rPr lang="en-US" dirty="0"/>
              <a:t>of bacterial species</a:t>
            </a:r>
          </a:p>
          <a:p>
            <a:r>
              <a:rPr lang="en-US" dirty="0"/>
              <a:t>related to </a:t>
            </a:r>
          </a:p>
          <a:p>
            <a:r>
              <a:rPr lang="en-US" dirty="0"/>
              <a:t>hospitalizations</a:t>
            </a:r>
          </a:p>
          <a:p>
            <a:r>
              <a:rPr lang="en-US" dirty="0"/>
              <a:t>at 90 days within</a:t>
            </a:r>
          </a:p>
          <a:p>
            <a:r>
              <a:rPr lang="en-US" dirty="0"/>
              <a:t>cirrhosis subgroups</a:t>
            </a:r>
          </a:p>
        </p:txBody>
      </p:sp>
    </p:spTree>
    <p:extLst>
      <p:ext uri="{BB962C8B-B14F-4D97-AF65-F5344CB8AC3E}">
        <p14:creationId xmlns:p14="http://schemas.microsoft.com/office/powerpoint/2010/main" val="24449279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able&#10;&#10;Description automatically generated">
            <a:extLst>
              <a:ext uri="{FF2B5EF4-FFF2-40B4-BE49-F238E27FC236}">
                <a16:creationId xmlns:a16="http://schemas.microsoft.com/office/drawing/2014/main" id="{D43BEEC8-83E2-418A-A78B-B484573F28B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1" t="5946" r="49389" b="2108"/>
          <a:stretch/>
        </p:blipFill>
        <p:spPr>
          <a:xfrm>
            <a:off x="2915217" y="86153"/>
            <a:ext cx="4556114" cy="668569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 descr="Table&#10;&#10;Description automatically generated">
            <a:extLst>
              <a:ext uri="{FF2B5EF4-FFF2-40B4-BE49-F238E27FC236}">
                <a16:creationId xmlns:a16="http://schemas.microsoft.com/office/drawing/2014/main" id="{AC91066C-3C3D-4178-ADC7-3102D90A862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98" t="5649" r="953" b="2715"/>
          <a:stretch/>
        </p:blipFill>
        <p:spPr>
          <a:xfrm>
            <a:off x="7568699" y="86153"/>
            <a:ext cx="4380766" cy="66668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5CDA1A4-7534-4B9E-A73E-8A21D2CB077C}"/>
              </a:ext>
            </a:extLst>
          </p:cNvPr>
          <p:cNvSpPr/>
          <p:nvPr/>
        </p:nvSpPr>
        <p:spPr>
          <a:xfrm>
            <a:off x="0" y="3270411"/>
            <a:ext cx="2525917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A: MaAsLin2 coefficients of variables linked with ↓ death</a:t>
            </a:r>
          </a:p>
          <a:p>
            <a:r>
              <a:rPr lang="en-US" b="1" dirty="0"/>
              <a:t>B: MaAsLin2 coefficients of variables linked with ↑ deat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031DB3-843E-43D8-A1CA-DA8724669817}"/>
              </a:ext>
            </a:extLst>
          </p:cNvPr>
          <p:cNvSpPr txBox="1"/>
          <p:nvPr/>
        </p:nvSpPr>
        <p:spPr>
          <a:xfrm>
            <a:off x="3051018" y="631026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4D2E1B3-BD61-4E73-BFD2-8E1721E8A979}"/>
              </a:ext>
            </a:extLst>
          </p:cNvPr>
          <p:cNvSpPr txBox="1"/>
          <p:nvPr/>
        </p:nvSpPr>
        <p:spPr>
          <a:xfrm>
            <a:off x="7607132" y="631026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D054EE7-2297-4CDF-8B56-940E75535AE2}"/>
              </a:ext>
            </a:extLst>
          </p:cNvPr>
          <p:cNvSpPr txBox="1"/>
          <p:nvPr/>
        </p:nvSpPr>
        <p:spPr>
          <a:xfrm>
            <a:off x="153908" y="540601"/>
            <a:ext cx="2682081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3</a:t>
            </a:r>
          </a:p>
          <a:p>
            <a:r>
              <a:rPr lang="en-US" dirty="0"/>
              <a:t>Multi-variable analysis</a:t>
            </a:r>
          </a:p>
          <a:p>
            <a:r>
              <a:rPr lang="en-US" dirty="0"/>
              <a:t>of bacterial species</a:t>
            </a:r>
          </a:p>
          <a:p>
            <a:r>
              <a:rPr lang="en-US" dirty="0"/>
              <a:t>related to death at 1 year</a:t>
            </a:r>
          </a:p>
          <a:p>
            <a:r>
              <a:rPr lang="en-US" dirty="0"/>
              <a:t>Within cirrhosis subgroups</a:t>
            </a:r>
          </a:p>
        </p:txBody>
      </p:sp>
    </p:spTree>
    <p:extLst>
      <p:ext uri="{BB962C8B-B14F-4D97-AF65-F5344CB8AC3E}">
        <p14:creationId xmlns:p14="http://schemas.microsoft.com/office/powerpoint/2010/main" val="17216601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4D73F42D-14DE-4310-90C1-4175980430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842191" y="1721360"/>
            <a:ext cx="6666844" cy="33334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Chart&#10;&#10;Description automatically generated">
            <a:extLst>
              <a:ext uri="{FF2B5EF4-FFF2-40B4-BE49-F238E27FC236}">
                <a16:creationId xmlns:a16="http://schemas.microsoft.com/office/drawing/2014/main" id="{B79D2334-33EE-47B0-946C-192ECA5F86E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558" b="6617"/>
          <a:stretch/>
        </p:blipFill>
        <p:spPr>
          <a:xfrm>
            <a:off x="6923721" y="3842562"/>
            <a:ext cx="5268279" cy="28789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 descr="Chart&#10;&#10;Description automatically generated">
            <a:extLst>
              <a:ext uri="{FF2B5EF4-FFF2-40B4-BE49-F238E27FC236}">
                <a16:creationId xmlns:a16="http://schemas.microsoft.com/office/drawing/2014/main" id="{F69871A5-4B9D-4AC9-9B41-9502FFEBEFA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636" t="38486" r="312" b="46826"/>
          <a:stretch/>
        </p:blipFill>
        <p:spPr>
          <a:xfrm>
            <a:off x="9130645" y="2843937"/>
            <a:ext cx="1376371" cy="6715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 descr="Chart, scatter chart&#10;&#10;Description automatically generated">
            <a:extLst>
              <a:ext uri="{FF2B5EF4-FFF2-40B4-BE49-F238E27FC236}">
                <a16:creationId xmlns:a16="http://schemas.microsoft.com/office/drawing/2014/main" id="{D4B97D0B-33E2-44D7-BF05-0A0B7245393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-1572847" y="1689642"/>
            <a:ext cx="6666844" cy="33968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2CBA206-0F7B-41AD-AD04-4E1082FE5CAD}"/>
              </a:ext>
            </a:extLst>
          </p:cNvPr>
          <p:cNvSpPr txBox="1"/>
          <p:nvPr/>
        </p:nvSpPr>
        <p:spPr>
          <a:xfrm>
            <a:off x="7329960" y="189419"/>
            <a:ext cx="4342727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4 Cirrhosis groups with and without</a:t>
            </a:r>
          </a:p>
          <a:p>
            <a:r>
              <a:rPr lang="en-US" b="1" dirty="0"/>
              <a:t>rifaximin</a:t>
            </a:r>
          </a:p>
          <a:p>
            <a:r>
              <a:rPr lang="en-US" dirty="0"/>
              <a:t>A: Comparison of bacterial species</a:t>
            </a:r>
          </a:p>
          <a:p>
            <a:r>
              <a:rPr lang="en-US" dirty="0"/>
              <a:t>B: Comparison of Virulence factors</a:t>
            </a:r>
          </a:p>
          <a:p>
            <a:r>
              <a:rPr lang="en-US" dirty="0"/>
              <a:t>C: Fold change in Virulence factors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641466B-92B6-4C7B-A912-95B01A9EFAD0}"/>
              </a:ext>
            </a:extLst>
          </p:cNvPr>
          <p:cNvSpPr txBox="1"/>
          <p:nvPr/>
        </p:nvSpPr>
        <p:spPr>
          <a:xfrm>
            <a:off x="79899" y="6352161"/>
            <a:ext cx="506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247070F-8682-4D1F-932B-A4AE3D44424E}"/>
              </a:ext>
            </a:extLst>
          </p:cNvPr>
          <p:cNvSpPr txBox="1"/>
          <p:nvPr/>
        </p:nvSpPr>
        <p:spPr>
          <a:xfrm>
            <a:off x="3540401" y="6352161"/>
            <a:ext cx="506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9555DA5-84A6-41AB-9366-8A271981C2D7}"/>
              </a:ext>
            </a:extLst>
          </p:cNvPr>
          <p:cNvSpPr txBox="1"/>
          <p:nvPr/>
        </p:nvSpPr>
        <p:spPr>
          <a:xfrm>
            <a:off x="6903749" y="6299249"/>
            <a:ext cx="506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020792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156</Words>
  <Application>Microsoft Office PowerPoint</Application>
  <PresentationFormat>Widescreen</PresentationFormat>
  <Paragraphs>3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jaj, Jasmohan S   RICVAMC</dc:creator>
  <cp:lastModifiedBy>jasmohan bajaj</cp:lastModifiedBy>
  <cp:revision>8</cp:revision>
  <dcterms:created xsi:type="dcterms:W3CDTF">2021-07-29T20:44:30Z</dcterms:created>
  <dcterms:modified xsi:type="dcterms:W3CDTF">2021-09-26T18:46:55Z</dcterms:modified>
</cp:coreProperties>
</file>